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64" r:id="rId3"/>
  </p:sldIdLst>
  <p:sldSz cx="9144000" cy="6858000" type="screen4x3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60" d="100"/>
          <a:sy n="160" d="100"/>
        </p:scale>
        <p:origin x="-936" y="1512"/>
      </p:cViewPr>
      <p:guideLst>
        <p:guide orient="horz" pos="2160"/>
        <p:guide pos="28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D406D3-C6C6-4066-905B-57D2B99A7C6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B73511-53C4-4FB5-B321-276FDCEFED1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1503680" y="3645535"/>
            <a:ext cx="5790565" cy="156845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just" fontAlgn="auto">
              <a:lnSpc>
                <a:spcPct val="200000"/>
              </a:lnSpc>
            </a:pPr>
            <a:r>
              <a:rPr lang="en-US" altLang="zh-CN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TTGCTTTAGA</a:t>
            </a:r>
            <a:r>
              <a:rPr lang="en-US" altLang="zh-CN" sz="1200" b="1" u="sng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T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GATTTTCCT</a:t>
            </a:r>
            <a:r>
              <a:rPr lang="en-US" altLang="zh-CN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AAAAATTTGATGAAA</a:t>
            </a:r>
            <a:r>
              <a:rPr lang="en-US" altLang="zh-CN" sz="1200" b="1" u="sng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AATTGCT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CACGTTTGTT</a:t>
            </a:r>
            <a:r>
              <a:rPr lang="en-US" altLang="zh-CN" sz="1200" b="1" u="sng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GAG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TAGAGATTTATTCGCGAAGAACTCTCAGAAAATCAGAAGATTTATAGAAA</a:t>
            </a:r>
            <a:r>
              <a:rPr lang="en-US" altLang="zh-CN" sz="1200" b="1" u="sng" dirty="0" smtClean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GGAAA</a:t>
            </a:r>
            <a:r>
              <a:rPr lang="en-US" altLang="zh-CN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ACATCG</a:t>
            </a:r>
            <a:r>
              <a:rPr lang="en-US" altLang="zh-CN" sz="1200" b="1" u="sng" dirty="0" smtClean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ATAA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CAATCGTACTCAAGAACGCTACGAGAAGCGTTTTCGATTAG</a:t>
            </a:r>
            <a:endParaRPr lang="en-US" altLang="zh-CN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 descr="基因簇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91640" y="2060575"/>
            <a:ext cx="5248910" cy="749935"/>
          </a:xfrm>
          <a:prstGeom prst="rect">
            <a:avLst/>
          </a:prstGeom>
        </p:spPr>
      </p:pic>
      <p:cxnSp>
        <p:nvCxnSpPr>
          <p:cNvPr id="2" name="直接连接符 1"/>
          <p:cNvCxnSpPr/>
          <p:nvPr/>
        </p:nvCxnSpPr>
        <p:spPr>
          <a:xfrm>
            <a:off x="4788059" y="2462721"/>
            <a:ext cx="0" cy="31355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>
            <a:off x="5363999" y="2462721"/>
            <a:ext cx="0" cy="32953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 flipH="1">
            <a:off x="1595914" y="2780724"/>
            <a:ext cx="3192145" cy="936625"/>
          </a:xfrm>
          <a:prstGeom prst="line">
            <a:avLst/>
          </a:prstGeom>
          <a:ln w="9525" cmpd="sng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5363999" y="2780377"/>
            <a:ext cx="1728470" cy="936625"/>
          </a:xfrm>
          <a:prstGeom prst="line">
            <a:avLst/>
          </a:prstGeom>
          <a:ln w="9525" cmpd="sng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31"/>
          <p:cNvSpPr txBox="1"/>
          <p:nvPr/>
        </p:nvSpPr>
        <p:spPr>
          <a:xfrm>
            <a:off x="2730818" y="3471011"/>
            <a:ext cx="504056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spC</a:t>
            </a:r>
            <a:endParaRPr lang="en-US" altLang="zh-CN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29"/>
          <p:cNvSpPr txBox="1"/>
          <p:nvPr/>
        </p:nvSpPr>
        <p:spPr>
          <a:xfrm>
            <a:off x="2587501" y="4005327"/>
            <a:ext cx="972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tart codon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28"/>
          <p:cNvSpPr txBox="1"/>
          <p:nvPr/>
        </p:nvSpPr>
        <p:spPr>
          <a:xfrm>
            <a:off x="2781729" y="4365476"/>
            <a:ext cx="4025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27"/>
          <p:cNvSpPr txBox="1"/>
          <p:nvPr/>
        </p:nvSpPr>
        <p:spPr>
          <a:xfrm>
            <a:off x="6515606" y="4004739"/>
            <a:ext cx="4025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3349397" y="4728071"/>
            <a:ext cx="1262380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pxR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inding 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t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 rot="10800000">
            <a:off x="2502321" y="3681222"/>
            <a:ext cx="791929" cy="36420"/>
            <a:chOff x="3809786" y="5480812"/>
            <a:chExt cx="791929" cy="36420"/>
          </a:xfrm>
        </p:grpSpPr>
        <p:cxnSp>
          <p:nvCxnSpPr>
            <p:cNvPr id="42" name="直接连接符 41"/>
            <p:cNvCxnSpPr/>
            <p:nvPr/>
          </p:nvCxnSpPr>
          <p:spPr>
            <a:xfrm>
              <a:off x="3809786" y="5480812"/>
              <a:ext cx="791929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 flipH="1">
              <a:off x="4506575" y="5480813"/>
              <a:ext cx="95140" cy="36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" name="文本框 27"/>
          <p:cNvSpPr txBox="1"/>
          <p:nvPr/>
        </p:nvSpPr>
        <p:spPr>
          <a:xfrm>
            <a:off x="4131310" y="3988435"/>
            <a:ext cx="50546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OC_GUID" val="{2f3cdf34-234c-4cfb-ae39-1316a15e7a29}"/>
  <p:tag name="KSO_WPP_MARK_KEY" val="79d8e96e-ce0d-4272-adaf-618b0546c7a7"/>
  <p:tag name="COMMONDATA" val="eyJoZGlkIjoiNGMzOTE1N2EzMzUwNzJmZWVkNmI2MDkwMGJlOTZiODc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0</Words>
  <Application>WPS 演示</Application>
  <PresentationFormat>全屏显示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微软雅黑</vt:lpstr>
      <vt:lpstr>Arial Unicode MS</vt:lpstr>
      <vt:lpstr>Calibri</vt:lpstr>
      <vt:lpstr>Office 主题​​</vt:lpstr>
      <vt:lpstr>PowerPoint 演示文稿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utoBVT</dc:creator>
  <cp:lastModifiedBy>lenovo</cp:lastModifiedBy>
  <cp:revision>89</cp:revision>
  <dcterms:created xsi:type="dcterms:W3CDTF">2015-04-07T09:56:00Z</dcterms:created>
  <dcterms:modified xsi:type="dcterms:W3CDTF">2022-10-21T10:50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598</vt:lpwstr>
  </property>
  <property fmtid="{D5CDD505-2E9C-101B-9397-08002B2CF9AE}" pid="3" name="ICV">
    <vt:lpwstr>051C6DFFCFD542BF9B49EC9DCD281119</vt:lpwstr>
  </property>
</Properties>
</file>